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2" d="100"/>
          <a:sy n="82" d="100"/>
        </p:scale>
        <p:origin x="67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roline Vinck - ERA" userId="fa641164-7837-47aa-927d-ccdc051a5863" providerId="ADAL" clId="{EF0A2444-D10D-473E-9CE9-0CD3D188E9A2}"/>
    <pc:docChg chg="delSld">
      <pc:chgData name="Caroline Vinck - ERA" userId="fa641164-7837-47aa-927d-ccdc051a5863" providerId="ADAL" clId="{EF0A2444-D10D-473E-9CE9-0CD3D188E9A2}" dt="2024-03-29T11:57:07.463" v="0" actId="47"/>
      <pc:docMkLst>
        <pc:docMk/>
      </pc:docMkLst>
      <pc:sldChg chg="del">
        <pc:chgData name="Caroline Vinck - ERA" userId="fa641164-7837-47aa-927d-ccdc051a5863" providerId="ADAL" clId="{EF0A2444-D10D-473E-9CE9-0CD3D188E9A2}" dt="2024-03-29T11:57:07.463" v="0" actId="47"/>
        <pc:sldMkLst>
          <pc:docMk/>
          <pc:sldMk cId="2040076619" sldId="256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B6D7C1-7CF0-38A8-F260-DE4F801A276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BA51F7B-ADD9-AF72-F948-79A16BFE941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85EE41-BD29-D7D7-231C-EDD9BDA5D4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300451-5488-4C29-AEC4-16465DFDA0F5}" type="datetimeFigureOut">
              <a:rPr lang="en-GB" smtClean="0"/>
              <a:t>29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CFB781-1C56-890C-F8B8-0F410D37DB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5C624D-5DC0-C4DD-3D50-D48F396A51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A7997-1EBB-4F77-B391-738754A7782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39643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C21D78-B8C2-81C2-4EC0-81B3B83092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81B5755-F51E-EB74-6644-C189E8965E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828114-E9B6-7AF4-E271-00DC2E1BEB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300451-5488-4C29-AEC4-16465DFDA0F5}" type="datetimeFigureOut">
              <a:rPr lang="en-GB" smtClean="0"/>
              <a:t>29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5544F9-A63C-491D-833A-4E3FB7A01E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D99C18-5360-E95D-6A6D-761A55FF7C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A7997-1EBB-4F77-B391-738754A7782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03439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CC42E28-AB4D-5FBB-5D75-E47402B67E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973CD79-9973-5B2F-498E-D62917B372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50DF91-CE32-F661-62CE-77EDD94AA8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300451-5488-4C29-AEC4-16465DFDA0F5}" type="datetimeFigureOut">
              <a:rPr lang="en-GB" smtClean="0"/>
              <a:t>29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C772CC-F217-6036-C0D5-F9B96A922A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93BB0A-255B-6139-D5F0-008F167769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A7997-1EBB-4F77-B391-738754A7782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88074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F17484-D78C-3459-3965-D4E9000643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C3ACC8-5435-97D6-453E-5E33570797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740833-5D3C-672D-F9BF-F54F92F52D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300451-5488-4C29-AEC4-16465DFDA0F5}" type="datetimeFigureOut">
              <a:rPr lang="en-GB" smtClean="0"/>
              <a:t>29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AF3A17-335A-EFE7-6DFC-DCE1BC1CD3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67827E-548C-EE73-1CC8-A03C71BFBF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A7997-1EBB-4F77-B391-738754A7782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6449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69C6CB-F505-8019-85C6-6D8C73C41F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322CFD-4ECE-2C98-6DCC-1F9BCF2B4A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4944E3-A2D6-E500-9A14-6042706E9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300451-5488-4C29-AEC4-16465DFDA0F5}" type="datetimeFigureOut">
              <a:rPr lang="en-GB" smtClean="0"/>
              <a:t>29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C840DC-A8BC-E3CF-A7AC-395A213FB1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ACA710-3E21-A86A-8489-7A0776B927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A7997-1EBB-4F77-B391-738754A7782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00358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3C58B4-F163-0787-516B-7F45463341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7B5E21-72C4-73A6-C468-1ECC7F1ABB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0B6AE9A-AA2A-46AA-4DB4-4CBC02E757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12E9A8-2430-D4BE-1B43-3A676DB0A3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300451-5488-4C29-AEC4-16465DFDA0F5}" type="datetimeFigureOut">
              <a:rPr lang="en-GB" smtClean="0"/>
              <a:t>29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7D2B61-009F-C9FD-F2D0-ACF3A2F47C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CFA3B8-26D9-C063-7D3D-26CEDFB061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A7997-1EBB-4F77-B391-738754A7782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36418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D01678-B31A-01AD-6376-D7AF535E28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469BC6-149E-360D-1DF2-45A06E428D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AD73E6C-07D9-1CF3-8021-BDBB98DE32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7A44D56-3C13-75A9-C4BB-5679C732CB9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EAC46E6-EE96-72CB-2482-7146661C95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3649088-BF7B-27D6-9C5D-3B29A11B2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300451-5488-4C29-AEC4-16465DFDA0F5}" type="datetimeFigureOut">
              <a:rPr lang="en-GB" smtClean="0"/>
              <a:t>29/03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FFB5A7F-2F63-F75C-AED8-070E035D1E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3118764-31C2-3871-38CB-E57F418081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A7997-1EBB-4F77-B391-738754A7782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56013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AF44AB-0BD7-F78D-0C94-79DF130D34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285A4B5-FA5D-EBB8-B723-EB61F08CDD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300451-5488-4C29-AEC4-16465DFDA0F5}" type="datetimeFigureOut">
              <a:rPr lang="en-GB" smtClean="0"/>
              <a:t>29/03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A198852-6D6F-6EF1-6B1A-FF676EE7AD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11E326-7D82-05CC-59E1-4ABEC49655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A7997-1EBB-4F77-B391-738754A7782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0515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241F206-8DDA-F8A6-6658-A7D346302D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300451-5488-4C29-AEC4-16465DFDA0F5}" type="datetimeFigureOut">
              <a:rPr lang="en-GB" smtClean="0"/>
              <a:t>29/03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FB5080A-7EC7-F89F-73AC-6CA5ABC62D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08EDB4-2249-B399-F1B1-962F4DD442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A7997-1EBB-4F77-B391-738754A7782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92663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AC5E9F-441A-F53E-82B6-1BEFDD0C4C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D76CEA-5F8C-A504-C052-C007FF2506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84D4CE-6CC2-450A-496D-76DFD6DF31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D0547B-62A6-44B2-3F41-18219B53E4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300451-5488-4C29-AEC4-16465DFDA0F5}" type="datetimeFigureOut">
              <a:rPr lang="en-GB" smtClean="0"/>
              <a:t>29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3CE16A-BB95-E5CC-182E-59F963BE6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2EA7EA-1F94-3C10-2894-768D08923C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A7997-1EBB-4F77-B391-738754A7782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1605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9ED62B-5045-19CF-9247-00A7A9A920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F2A4574-4C4C-AFB2-F673-8239FF8BAC7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C787DB-619B-23A3-01E7-36AA83153E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504BAD-BD76-B83F-130D-5BD543E644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300451-5488-4C29-AEC4-16465DFDA0F5}" type="datetimeFigureOut">
              <a:rPr lang="en-GB" smtClean="0"/>
              <a:t>29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0AAE10-AC76-FCE2-A400-A9B746046A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0F0A45-B617-4D7E-0E60-8AA729B50E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A7997-1EBB-4F77-B391-738754A7782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37497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B799B09-259B-FF14-C9A2-C36DC9D23B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A9A064-67E3-02A4-1508-8C8F19978D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10FFBE-4CAB-12E3-4953-F10101EF78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300451-5488-4C29-AEC4-16465DFDA0F5}" type="datetimeFigureOut">
              <a:rPr lang="en-GB" smtClean="0"/>
              <a:t>29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87BCBF-24E9-1A98-FD8E-41828089892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C91F41-E56F-B975-668A-FE8F996875C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AA7997-1EBB-4F77-B391-738754A7782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866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EB49B728-DA98-AD29-2F9A-4FA5BE56C59E}"/>
              </a:ext>
            </a:extLst>
          </p:cNvPr>
          <p:cNvGrpSpPr/>
          <p:nvPr/>
        </p:nvGrpSpPr>
        <p:grpSpPr>
          <a:xfrm>
            <a:off x="2517457" y="741045"/>
            <a:ext cx="7157085" cy="5375910"/>
            <a:chOff x="0" y="0"/>
            <a:chExt cx="7628890" cy="5744953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173BFF32-0BB8-B0A5-DB08-5F2D5781E100}"/>
                </a:ext>
              </a:extLst>
            </p:cNvPr>
            <p:cNvSpPr/>
            <p:nvPr/>
          </p:nvSpPr>
          <p:spPr>
            <a:xfrm>
              <a:off x="0" y="0"/>
              <a:ext cx="7628890" cy="5507665"/>
            </a:xfrm>
            <a:prstGeom prst="rect">
              <a:avLst/>
            </a:prstGeom>
            <a:noFill/>
            <a:ln w="19050"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6" name="TextBox 4">
              <a:extLst>
                <a:ext uri="{FF2B5EF4-FFF2-40B4-BE49-F238E27FC236}">
                  <a16:creationId xmlns:a16="http://schemas.microsoft.com/office/drawing/2014/main" id="{485456CA-AB7B-D071-1A21-585FCEFB8F1E}"/>
                </a:ext>
              </a:extLst>
            </p:cNvPr>
            <p:cNvSpPr txBox="1"/>
            <p:nvPr/>
          </p:nvSpPr>
          <p:spPr>
            <a:xfrm>
              <a:off x="1915064" y="69011"/>
              <a:ext cx="4284921" cy="27644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GB" sz="10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upplementary Figure 1. Number of patients recruited at each site</a:t>
              </a:r>
              <a:endParaRPr lang="en-GB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4">
              <a:extLst>
                <a:ext uri="{FF2B5EF4-FFF2-40B4-BE49-F238E27FC236}">
                  <a16:creationId xmlns:a16="http://schemas.microsoft.com/office/drawing/2014/main" id="{A73A55A9-D1F3-4308-B108-674A6BBAAC69}"/>
                </a:ext>
              </a:extLst>
            </p:cNvPr>
            <p:cNvSpPr txBox="1"/>
            <p:nvPr/>
          </p:nvSpPr>
          <p:spPr>
            <a:xfrm>
              <a:off x="0" y="5503653"/>
              <a:ext cx="7628890" cy="241300"/>
            </a:xfrm>
            <a:prstGeom prst="rect">
              <a:avLst/>
            </a:prstGeom>
            <a:noFill/>
            <a:ln w="19050">
              <a:solidFill>
                <a:schemeClr val="bg1">
                  <a:lumMod val="85000"/>
                </a:schemeClr>
              </a:solidFill>
            </a:ln>
          </p:spPr>
          <p:txBody>
            <a:bodyPr wrap="square" rtlCol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US" sz="1000" b="1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Recruitment sites: </a:t>
              </a:r>
              <a:r>
                <a:rPr lang="en-US" sz="10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dult sites unless otherwise stated. </a:t>
              </a:r>
              <a:r>
                <a:rPr lang="en-US" sz="1000" b="1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endParaRPr lang="en-GB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8" name="Picture 7" descr="A graph of different colored bars&#10;&#10;Description automatically generated">
              <a:extLst>
                <a:ext uri="{FF2B5EF4-FFF2-40B4-BE49-F238E27FC236}">
                  <a16:creationId xmlns:a16="http://schemas.microsoft.com/office/drawing/2014/main" id="{ED9047A0-8845-5729-22F6-1849163E051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878"/>
            <a:stretch/>
          </p:blipFill>
          <p:spPr bwMode="auto">
            <a:xfrm>
              <a:off x="698740" y="474453"/>
              <a:ext cx="6332855" cy="4967605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0773346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1E833B98-ADAF-EB21-791A-2730AC335CA5}"/>
              </a:ext>
            </a:extLst>
          </p:cNvPr>
          <p:cNvGrpSpPr/>
          <p:nvPr/>
        </p:nvGrpSpPr>
        <p:grpSpPr>
          <a:xfrm>
            <a:off x="3396343" y="1175657"/>
            <a:ext cx="4677047" cy="3990068"/>
            <a:chOff x="0" y="0"/>
            <a:chExt cx="5540887" cy="4558352"/>
          </a:xfrm>
        </p:grpSpPr>
        <p:pic>
          <p:nvPicPr>
            <p:cNvPr id="3" name="Picture 2" descr="A graph with blue and white lines&#10;&#10;Description automatically generated">
              <a:extLst>
                <a:ext uri="{FF2B5EF4-FFF2-40B4-BE49-F238E27FC236}">
                  <a16:creationId xmlns:a16="http://schemas.microsoft.com/office/drawing/2014/main" id="{65DD95C7-407F-3563-3709-DECA77002B7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8822"/>
            <a:stretch/>
          </p:blipFill>
          <p:spPr>
            <a:xfrm>
              <a:off x="218364" y="846161"/>
              <a:ext cx="5139055" cy="3561715"/>
            </a:xfrm>
            <a:prstGeom prst="rect">
              <a:avLst/>
            </a:prstGeom>
          </p:spPr>
        </p:pic>
        <p:sp>
          <p:nvSpPr>
            <p:cNvPr id="6" name="TextBox 4">
              <a:extLst>
                <a:ext uri="{FF2B5EF4-FFF2-40B4-BE49-F238E27FC236}">
                  <a16:creationId xmlns:a16="http://schemas.microsoft.com/office/drawing/2014/main" id="{1711505D-46E1-4B61-2253-AF76A8339CD2}"/>
                </a:ext>
              </a:extLst>
            </p:cNvPr>
            <p:cNvSpPr txBox="1"/>
            <p:nvPr/>
          </p:nvSpPr>
          <p:spPr>
            <a:xfrm>
              <a:off x="156051" y="133671"/>
              <a:ext cx="5263680" cy="57882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GB" sz="10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</a:rPr>
                <a:t>Supplementary Figure 2. Number of years between diagnosis and first study visit</a:t>
              </a:r>
              <a:endParaRPr lang="en-GB" sz="1000" dirty="0">
                <a:effectLst/>
                <a:latin typeface="Calibri" panose="020F0502020204030204" pitchFamily="34" charset="0"/>
                <a:ea typeface="Calibri" panose="020F0502020204030204" pitchFamily="34" charset="0"/>
              </a:endParaRP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C4A34356-B975-B9E7-8FBD-10896DA4169F}"/>
                </a:ext>
              </a:extLst>
            </p:cNvPr>
            <p:cNvSpPr/>
            <p:nvPr/>
          </p:nvSpPr>
          <p:spPr>
            <a:xfrm>
              <a:off x="0" y="0"/>
              <a:ext cx="5540887" cy="4558352"/>
            </a:xfrm>
            <a:prstGeom prst="rect">
              <a:avLst/>
            </a:prstGeom>
            <a:noFill/>
            <a:ln w="19050"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23914938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</Words>
  <Application>Microsoft Office PowerPoint</Application>
  <PresentationFormat>Breedbeeld</PresentationFormat>
  <Paragraphs>3</Paragraphs>
  <Slides>2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-presentatie</vt:lpstr>
      <vt:lpstr>PowerPoint-presentati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antha Hayward</dc:creator>
  <cp:lastModifiedBy>Caroline Vinck - ERA</cp:lastModifiedBy>
  <cp:revision>3</cp:revision>
  <dcterms:created xsi:type="dcterms:W3CDTF">2024-01-29T11:31:45Z</dcterms:created>
  <dcterms:modified xsi:type="dcterms:W3CDTF">2024-03-29T11:57:08Z</dcterms:modified>
</cp:coreProperties>
</file>